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7" r:id="rId3"/>
    <p:sldId id="268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밝은 스타일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65" autoAdjust="0"/>
    <p:restoredTop sz="94701"/>
  </p:normalViewPr>
  <p:slideViewPr>
    <p:cSldViewPr snapToGrid="0">
      <p:cViewPr varScale="1">
        <p:scale>
          <a:sx n="79" d="100"/>
          <a:sy n="79" d="100"/>
        </p:scale>
        <p:origin x="120" y="6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398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8111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5740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05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4226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280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8570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8320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8300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2737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6947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FBC9B-06A4-4437-9711-3258F774FB64}" type="datetimeFigureOut">
              <a:rPr lang="ko-KR" altLang="en-US" smtClean="0"/>
              <a:t>2021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7F18C-FCB7-453B-B382-C93209594F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376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개체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014261"/>
              </p:ext>
            </p:extLst>
          </p:nvPr>
        </p:nvGraphicFramePr>
        <p:xfrm>
          <a:off x="522476" y="3183154"/>
          <a:ext cx="3905937" cy="2693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6" name="Prism 9" r:id="rId3" imgW="3855613" imgH="2712320" progId="Prism9.Document">
                  <p:embed/>
                </p:oleObj>
              </mc:Choice>
              <mc:Fallback>
                <p:oleObj name="Prism 9" r:id="rId3" imgW="3855613" imgH="2712320" progId="Prism9.Document">
                  <p:embed/>
                  <p:pic>
                    <p:nvPicPr>
                      <p:cNvPr id="6" name="개체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2476" y="3183154"/>
                        <a:ext cx="3905937" cy="2693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개체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3689812"/>
              </p:ext>
            </p:extLst>
          </p:nvPr>
        </p:nvGraphicFramePr>
        <p:xfrm>
          <a:off x="6619535" y="3183154"/>
          <a:ext cx="3891946" cy="27205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7" name="Prism 9" r:id="rId5" imgW="3860295" imgH="2698634" progId="Prism9.Document">
                  <p:embed/>
                </p:oleObj>
              </mc:Choice>
              <mc:Fallback>
                <p:oleObj name="Prism 9" r:id="rId5" imgW="3860295" imgH="2698634" progId="Prism9.Document">
                  <p:embed/>
                  <p:pic>
                    <p:nvPicPr>
                      <p:cNvPr id="10" name="개체 9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619535" y="3183154"/>
                        <a:ext cx="3891946" cy="27205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개체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433924"/>
              </p:ext>
            </p:extLst>
          </p:nvPr>
        </p:nvGraphicFramePr>
        <p:xfrm>
          <a:off x="438150" y="482600"/>
          <a:ext cx="3759200" cy="2725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8" name="Prism 9" r:id="rId7" imgW="3855613" imgH="2794795" progId="Prism9.Document">
                  <p:embed/>
                </p:oleObj>
              </mc:Choice>
              <mc:Fallback>
                <p:oleObj name="Prism 9" r:id="rId7" imgW="3855613" imgH="279479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8150" y="482600"/>
                        <a:ext cx="3759200" cy="2725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제목 1"/>
          <p:cNvSpPr>
            <a:spLocks noGrp="1"/>
          </p:cNvSpPr>
          <p:nvPr>
            <p:ph type="title"/>
          </p:nvPr>
        </p:nvSpPr>
        <p:spPr>
          <a:xfrm>
            <a:off x="437463" y="5564813"/>
            <a:ext cx="11498504" cy="1325563"/>
          </a:xfrm>
        </p:spPr>
        <p:txBody>
          <a:bodyPr>
            <a:normAutofit/>
          </a:bodyPr>
          <a:lstStyle/>
          <a:p>
            <a:r>
              <a:rPr lang="en-US" altLang="ko-KR" sz="1400" b="1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4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400" b="1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4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Kaplan-Meier curves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progression-free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rvival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 A) first-, B) second-, C) third-line palliative treatment, and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overall survival in the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bgroups. Subgroups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include 1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nriched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, right-sided colon cancer, 2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ko-KR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, right-sided colon cancer, 3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ko-KR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enriched, left-sided colon, and 4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, left-sided colon.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2476" y="168365"/>
            <a:ext cx="2089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14258" y="107405"/>
            <a:ext cx="2089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106594" y="2281423"/>
            <a:ext cx="922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</a:t>
            </a:r>
            <a:r>
              <a:rPr lang="en-US" altLang="ko-KR" sz="1400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 = 0.20</a:t>
            </a:r>
            <a:endParaRPr lang="ko-KR" altLang="en-US" sz="1400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9460449" y="4979431"/>
            <a:ext cx="1009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</a:t>
            </a:r>
            <a:r>
              <a:rPr lang="en-US" altLang="ko-KR" sz="1400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 = 0.99</a:t>
            </a:r>
            <a:endParaRPr lang="ko-KR" altLang="en-US" sz="1400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graphicFrame>
        <p:nvGraphicFramePr>
          <p:cNvPr id="9" name="개체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6800460"/>
              </p:ext>
            </p:extLst>
          </p:nvPr>
        </p:nvGraphicFramePr>
        <p:xfrm>
          <a:off x="6554895" y="381519"/>
          <a:ext cx="4021226" cy="2828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9" name="Prism 9" r:id="rId9" imgW="3855613" imgH="2712320" progId="Prism9.Document">
                  <p:embed/>
                </p:oleObj>
              </mc:Choice>
              <mc:Fallback>
                <p:oleObj name="Prism 9" r:id="rId9" imgW="3855613" imgH="2712320" progId="Prism9.Document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554895" y="381519"/>
                        <a:ext cx="4021226" cy="2828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86057" y="2954047"/>
            <a:ext cx="2089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614258" y="2954047"/>
            <a:ext cx="2089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498605" y="2285538"/>
            <a:ext cx="922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 </a:t>
            </a:r>
            <a:r>
              <a:rPr lang="en-US" altLang="ko-KR" sz="1400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= 0.19</a:t>
            </a:r>
            <a:endParaRPr lang="ko-KR" altLang="en-US" sz="1400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61858" y="4957877"/>
            <a:ext cx="922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 </a:t>
            </a:r>
            <a:r>
              <a:rPr lang="en-US" altLang="ko-KR" sz="1400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= 0.48</a:t>
            </a:r>
            <a:endParaRPr lang="ko-KR" altLang="en-US" sz="1400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2631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개체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0485834"/>
              </p:ext>
            </p:extLst>
          </p:nvPr>
        </p:nvGraphicFramePr>
        <p:xfrm>
          <a:off x="409575" y="1628775"/>
          <a:ext cx="5586413" cy="332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03" name="Prism 9" r:id="rId3" imgW="4555357" imgH="2712320" progId="Prism9.Document">
                  <p:embed/>
                </p:oleObj>
              </mc:Choice>
              <mc:Fallback>
                <p:oleObj name="Prism 9" r:id="rId3" imgW="4555357" imgH="2712320" progId="Prism9.Document">
                  <p:embed/>
                  <p:pic>
                    <p:nvPicPr>
                      <p:cNvPr id="4" name="개체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9575" y="1628775"/>
                        <a:ext cx="5586413" cy="332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개체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8036103"/>
              </p:ext>
            </p:extLst>
          </p:nvPr>
        </p:nvGraphicFramePr>
        <p:xfrm>
          <a:off x="6376256" y="1657289"/>
          <a:ext cx="5263730" cy="3378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04" name="Prism 9" r:id="rId5" imgW="4204945" imgH="2698634" progId="Prism9.Document">
                  <p:embed/>
                </p:oleObj>
              </mc:Choice>
              <mc:Fallback>
                <p:oleObj name="Prism 9" r:id="rId5" imgW="4204945" imgH="2698634" progId="Prism9.Document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376256" y="1657289"/>
                        <a:ext cx="5263730" cy="3378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41734" y="1009853"/>
            <a:ext cx="2089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746527" y="1100707"/>
            <a:ext cx="2089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제목 1"/>
          <p:cNvSpPr txBox="1">
            <a:spLocks/>
          </p:cNvSpPr>
          <p:nvPr/>
        </p:nvSpPr>
        <p:spPr>
          <a:xfrm>
            <a:off x="386743" y="5116146"/>
            <a:ext cx="1149850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400" b="1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400" b="1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altLang="ko-KR" sz="1400" b="1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Kaplan-Meier curves of A) progression-free survival and B) overall survival in the subgroups by chemotherapy treated in the first-line palliative setting.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bgroups include 1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nriched, FOLFIRI treated colon cancer, 2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, FOLFIRI treated colon cancer, 3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nriched, FOLFOX treated colon cancer, and 4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, FOLFOX treated colon cancer.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03414" y="3903049"/>
            <a:ext cx="922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</a:t>
            </a:r>
            <a:r>
              <a:rPr lang="en-US" altLang="ko-KR" sz="1400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 = 0.34</a:t>
            </a:r>
            <a:endParaRPr lang="ko-KR" altLang="en-US" sz="1400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028094" y="3928731"/>
            <a:ext cx="922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</a:t>
            </a:r>
            <a:r>
              <a:rPr lang="en-US" altLang="ko-KR" sz="1400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 = 0.23</a:t>
            </a:r>
            <a:endParaRPr lang="ko-KR" altLang="en-US" sz="1400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4636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개체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4334308"/>
              </p:ext>
            </p:extLst>
          </p:nvPr>
        </p:nvGraphicFramePr>
        <p:xfrm>
          <a:off x="6281738" y="1836738"/>
          <a:ext cx="5037137" cy="272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8" name="Prism 9" r:id="rId3" imgW="4996163" imgH="2698634" progId="Prism9.Document">
                  <p:embed/>
                </p:oleObj>
              </mc:Choice>
              <mc:Fallback>
                <p:oleObj name="Prism 9" r:id="rId3" imgW="4996163" imgH="2698634" progId="Prism9.Document">
                  <p:embed/>
                  <p:pic>
                    <p:nvPicPr>
                      <p:cNvPr id="23" name="개체 2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81738" y="1836738"/>
                        <a:ext cx="5037137" cy="2720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개체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1187513"/>
              </p:ext>
            </p:extLst>
          </p:nvPr>
        </p:nvGraphicFramePr>
        <p:xfrm>
          <a:off x="928688" y="1912938"/>
          <a:ext cx="5086350" cy="264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9" name="Prism 9" r:id="rId5" imgW="5218727" imgH="2712320" progId="Prism9.Document">
                  <p:embed/>
                </p:oleObj>
              </mc:Choice>
              <mc:Fallback>
                <p:oleObj name="Prism 9" r:id="rId5" imgW="5218727" imgH="2712320" progId="Prism9.Document">
                  <p:embed/>
                  <p:pic>
                    <p:nvPicPr>
                      <p:cNvPr id="12" name="개체 1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28688" y="1912938"/>
                        <a:ext cx="5086350" cy="2644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제목 1"/>
          <p:cNvSpPr>
            <a:spLocks noGrp="1"/>
          </p:cNvSpPr>
          <p:nvPr>
            <p:ph type="title"/>
          </p:nvPr>
        </p:nvSpPr>
        <p:spPr>
          <a:xfrm>
            <a:off x="437463" y="5564813"/>
            <a:ext cx="11498504" cy="1325563"/>
          </a:xfrm>
        </p:spPr>
        <p:txBody>
          <a:bodyPr>
            <a:normAutofit/>
          </a:bodyPr>
          <a:lstStyle/>
          <a:p>
            <a:r>
              <a:rPr lang="en-US" altLang="ko-KR" sz="1400" b="1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400" b="1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en-US" altLang="ko-KR" sz="1400" b="1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Kaplan-Meier curves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A) progression-free survival and B) overall survival for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subgroups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in the validation cohort using The Cancer Genome Atlas (TCGA) colon cancer data.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bgroups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include 1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nriched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, right-sided colon cancer, 2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ko-KR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, right-sided colon cancer, 3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ko-KR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enriched, left-sided colon, and 4) </a:t>
            </a:r>
            <a:r>
              <a:rPr lang="en-US" altLang="ko-KR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altLang="ko-KR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, left-sided colon.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62173" y="1402361"/>
            <a:ext cx="2089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853955" y="1341401"/>
            <a:ext cx="2089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615798" y="3629032"/>
            <a:ext cx="922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</a:t>
            </a:r>
            <a:r>
              <a:rPr lang="en-US" altLang="ko-KR" sz="1400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 = 0.04</a:t>
            </a:r>
            <a:endParaRPr lang="ko-KR" altLang="en-US" sz="1400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919652" y="3629032"/>
            <a:ext cx="922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 </a:t>
            </a:r>
            <a:r>
              <a:rPr lang="en-US" altLang="ko-KR" sz="1400" dirty="0" smtClean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= 0.10</a:t>
            </a:r>
            <a:endParaRPr lang="ko-KR" altLang="en-US" sz="1400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5633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254</Words>
  <Application>Microsoft Office PowerPoint</Application>
  <PresentationFormat>와이드스크린</PresentationFormat>
  <Paragraphs>19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Times New Roman</vt:lpstr>
      <vt:lpstr>Office 테마</vt:lpstr>
      <vt:lpstr>Prism 9</vt:lpstr>
      <vt:lpstr>Supplementary Figure S1. Kaplan-Meier curves of progression-free survival in A) first-, B) second-, C) third-line palliative treatment, and D) overall survival in the subgroups. Subgroups include 1) Fn enriched, right-sided colon cancer, 2) Fn negative, right-sided colon cancer, 3) Fn enriched, left-sided colon, and 4) Fn negative, left-sided colon. </vt:lpstr>
      <vt:lpstr>PowerPoint 프레젠테이션</vt:lpstr>
      <vt:lpstr>Supplementary Figure S3. Kaplan-Meier curves of of A) progression-free survival and B) overall survival for the subgroups in the validation cohort using The Cancer Genome Atlas (TCGA) colon cancer data. Subgroups include 1) Fn enriched, right-sided colon cancer, 2) Fn negative, right-sided colon cancer, 3) Fn enriched, left-sided colon, and 4) Fn negative, left-sided colon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usobacterium</dc:title>
  <dc:creator>이기쁨(강남)종양내과)</dc:creator>
  <cp:lastModifiedBy>SV34BA6WDS002</cp:lastModifiedBy>
  <cp:revision>183</cp:revision>
  <dcterms:created xsi:type="dcterms:W3CDTF">2020-07-09T08:53:14Z</dcterms:created>
  <dcterms:modified xsi:type="dcterms:W3CDTF">2021-08-18T11:27:01Z</dcterms:modified>
</cp:coreProperties>
</file>